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16202025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432" y="7242"/>
      </p:cViewPr>
      <p:guideLst>
        <p:guide orient="horz" pos="5103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521DA1E-CEC2-4F8A-9FF6-F6209E9FC578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462213" y="685800"/>
            <a:ext cx="1933575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D86183C-B016-4487-950F-9195114E2B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898025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462213" y="685800"/>
            <a:ext cx="1933575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D86183C-B016-4487-950F-9195114E2B1A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3905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5033131"/>
            <a:ext cx="7772400" cy="3472934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9181148"/>
            <a:ext cx="6400800" cy="414051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9293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805918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1702713"/>
            <a:ext cx="2057400" cy="3628953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1702713"/>
            <a:ext cx="6019800" cy="3628953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43724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3447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10411303"/>
            <a:ext cx="7772400" cy="321790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6867111"/>
            <a:ext cx="7772400" cy="3544192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08570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9923741"/>
            <a:ext cx="4038600" cy="280685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9923741"/>
            <a:ext cx="4038600" cy="2806850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515579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648833"/>
            <a:ext cx="8229600" cy="2700338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3626705"/>
            <a:ext cx="4040188" cy="15114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5138143"/>
            <a:ext cx="4040188" cy="933491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7" y="3626705"/>
            <a:ext cx="4041775" cy="151143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7" y="5138143"/>
            <a:ext cx="4041775" cy="933491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4857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5259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3943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2" y="645081"/>
            <a:ext cx="3008313" cy="2745343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645081"/>
            <a:ext cx="5111750" cy="1382798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2" y="3390425"/>
            <a:ext cx="3008313" cy="11082636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19073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11341418"/>
            <a:ext cx="5486400" cy="133891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1447681"/>
            <a:ext cx="5486400" cy="972121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12680336"/>
            <a:ext cx="5486400" cy="190148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42751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648833"/>
            <a:ext cx="8229600" cy="27003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3780474"/>
            <a:ext cx="8229600" cy="1069258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15016878"/>
            <a:ext cx="2133600" cy="862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B78AC5-CEE1-47BC-9DBE-3FD1138606E5}" type="datetimeFigureOut">
              <a:rPr lang="zh-CN" altLang="en-US" smtClean="0"/>
              <a:t>2014/7/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15016878"/>
            <a:ext cx="2895600" cy="862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15016878"/>
            <a:ext cx="2133600" cy="8626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80C90E-CFCD-4A56-9894-C1A633FE203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357766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TextBox 15"/>
          <p:cNvSpPr txBox="1"/>
          <p:nvPr/>
        </p:nvSpPr>
        <p:spPr>
          <a:xfrm>
            <a:off x="-35718" y="-32303"/>
            <a:ext cx="1812798" cy="435710"/>
          </a:xfrm>
          <a:prstGeom prst="rect">
            <a:avLst/>
          </a:prstGeom>
          <a:noFill/>
        </p:spPr>
        <p:txBody>
          <a:bodyPr wrap="square" lIns="157176" tIns="78588" rIns="157176" bIns="78588" rtlCol="0">
            <a:spAutoFit/>
          </a:bodyPr>
          <a:lstStyle/>
          <a:p>
            <a:r>
              <a:rPr lang="en-US" altLang="zh-CN" sz="1800" smtClean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endParaRPr lang="zh-CN" altLang="en-US" sz="1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971600" y="356540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zh-CN" altLang="en-US" sz="18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71600" y="7083608"/>
            <a:ext cx="3385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800" kern="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zh-CN" altLang="en-US" sz="1800" b="0" i="0" u="none" strike="noStrike" kern="0" cap="none" spc="0" normalizeH="0" baseline="0" noProof="0" dirty="0" smtClean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9" name="表格 1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0492837"/>
              </p:ext>
            </p:extLst>
          </p:nvPr>
        </p:nvGraphicFramePr>
        <p:xfrm>
          <a:off x="1442442" y="7232871"/>
          <a:ext cx="6874768" cy="8232479"/>
        </p:xfrm>
        <a:graphic>
          <a:graphicData uri="http://schemas.openxmlformats.org/drawingml/2006/table">
            <a:tbl>
              <a:tblPr/>
              <a:tblGrid>
                <a:gridCol w="6082680"/>
                <a:gridCol w="792088"/>
              </a:tblGrid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</a:t>
                      </a:r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GCCACCCGATCCACTGG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L2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g</a:t>
                      </a:r>
                      <a:r>
                        <a:rPr lang="en-US" altLang="zh-CN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-TGG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C-GG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-------TGG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7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-------------TGG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3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---------------------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1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TGTGTGG---//--------------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44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TGTGT---//------------------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48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C</a:t>
                      </a:r>
                      <a:r>
                        <a:rPr lang="en-US" sz="1200" b="0" i="0" u="none" strike="noStrike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1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C</a:t>
                      </a:r>
                      <a:r>
                        <a:rPr lang="en-US" sz="1200" b="0" i="0" u="none" strike="noStrike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ATA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3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</a:t>
                      </a:r>
                      <a:r>
                        <a:rPr lang="en-US" sz="1200" b="0" i="0" u="none" strike="noStrike">
                          <a:solidFill>
                            <a:srgbClr val="FF3399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200" b="0" i="0" u="none" strike="noStrike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TTT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GGGAGCAAAACTTCAAAGGGTAAAATGGGCC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3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marL="0" marR="0" indent="0" algn="l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</a:t>
                      </a:r>
                      <a:r>
                        <a:rPr lang="en-US" sz="1200" b="0" i="0" u="sng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TGGACCTTGAATGCTGG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AGCCACTTCTGGCTTCTGACC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G1</a:t>
                      </a:r>
                      <a:r>
                        <a:rPr lang="en-US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marL="0" marR="0" indent="0" algn="l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marL="0" marR="0" indent="0" algn="l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6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marL="0" marR="0" indent="0" algn="l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T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9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marL="0" marR="0" indent="0" algn="l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7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marL="0" marR="0" indent="0" algn="l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-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4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marL="0" marR="0" indent="0" algn="l" defTabSz="1571762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TGC</a:t>
                      </a:r>
                      <a:r>
                        <a:rPr lang="en-US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T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1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</a:t>
                      </a:r>
                      <a:r>
                        <a:rPr lang="en-US" sz="1200" b="0" i="0" u="sng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AGTTCTCTTTGGAGGA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G2</a:t>
                      </a:r>
                      <a:r>
                        <a:rPr lang="en-US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-GGA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—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6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7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4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6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//------------------------------GCCTTCTAA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8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-</a:t>
                      </a:r>
                      <a:r>
                        <a:rPr lang="en-US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GT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, +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A</a:t>
                      </a:r>
                      <a:r>
                        <a:rPr lang="en-US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1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A</a:t>
                      </a:r>
                      <a:r>
                        <a:rPr lang="en-US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GAG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CGGTCATACATGCCTTCTAATCAAAGAACC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3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CCCAC</a:t>
                      </a:r>
                      <a:r>
                        <a:rPr lang="en-US" sz="1200" b="0" i="0" u="sng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CGCTGTCCCGCGGCGCG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GCTCCCGCTTCTGCCAACTGCGAGCTC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IKI1</a:t>
                      </a:r>
                      <a:r>
                        <a:rPr lang="en-US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CCCACGGGCGCTGTCCCGCG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GCTCCCGCTTCTGCCAACTGCGAGCTC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5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CCCACGGGCGCTGTCCCG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GCTCCCGCTTCTGCCAACTGCGAGCTC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7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CCCACGGGCGCTGTCCCGC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CTGCCAACTGCGAGCTC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6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CCCACGGGCGCTG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----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CAACTGCGAGCTC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7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CCCACGGGCG</a:t>
                      </a:r>
                      <a:r>
                        <a:rPr lang="en-US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AGGCTCCCGCTTCTGCCAACTGCGAGCTCAA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, -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ACCCCT</a:t>
                      </a:r>
                      <a:r>
                        <a:rPr lang="en-US" sz="1200" b="0" i="0" u="sng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ATAAGCAGAGCTGAAG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GAAAAGAAGGGAGATAAAGGTTACCCACT</a:t>
                      </a: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LB</a:t>
                      </a:r>
                      <a:r>
                        <a:rPr lang="en-US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ACCCCTGGAATAAGC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GAGGAAAAGAAGGGAGATAAAGG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ACCCA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7</a:t>
                      </a:r>
                    </a:p>
                  </a:txBody>
                  <a:tcPr marL="9525" marR="9525" marT="857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ACCCCTGGAATAAGC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AGGAAAAGAAGGGAGATAAAGG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ACCCA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8</a:t>
                      </a: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ACCCCTGGAATAA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GAGGAAAAGAAGGGAGATAAAGG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ACCCA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9</a:t>
                      </a: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ACCCCTGGAAT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GAGGAAAAGAAGGGAGATAAAGG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ACCCA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1</a:t>
                      </a: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ACCCCTGGAATAAGCAGAGCT</a:t>
                      </a:r>
                      <a:r>
                        <a:rPr lang="en-US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200" b="0" i="0" u="none" strike="noStrike" smtClean="0">
                          <a:solidFill>
                            <a:srgbClr val="FF3399"/>
                          </a:solidFill>
                          <a:effectLst/>
                          <a:latin typeface="Courier New"/>
                        </a:rPr>
                        <a:t>CCCTTTCAAG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AAGGGAGATAAAGG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TACCCAC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1</a:t>
                      </a: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0999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ATC</a:t>
                      </a:r>
                      <a:r>
                        <a:rPr lang="en-US" sz="1200" b="0" i="0" u="none" strike="noStrike" dirty="0">
                          <a:solidFill>
                            <a:srgbClr val="FF3399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-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//----</a:t>
                      </a:r>
                      <a:r>
                        <a:rPr lang="en-US" sz="1200" b="0" i="0" u="none" strike="noStrike" dirty="0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GACCGGTCAGCTGGAATTCCAGCGGGGTACCCCG</a:t>
                      </a:r>
                      <a:r>
                        <a:rPr lang="en-US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TGCCAAA</a:t>
                      </a:r>
                      <a:endParaRPr lang="en-US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0, +</a:t>
                      </a:r>
                      <a:r>
                        <a:rPr lang="en-US" alt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</a:t>
                      </a:r>
                    </a:p>
                  </a:txBody>
                  <a:tcPr marL="9525" marR="9525" marT="8573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graphicFrame>
        <p:nvGraphicFramePr>
          <p:cNvPr id="20" name="表格 1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67320688"/>
              </p:ext>
            </p:extLst>
          </p:nvPr>
        </p:nvGraphicFramePr>
        <p:xfrm>
          <a:off x="1413358" y="634347"/>
          <a:ext cx="6831845" cy="6242528"/>
        </p:xfrm>
        <a:graphic>
          <a:graphicData uri="http://schemas.openxmlformats.org/drawingml/2006/table">
            <a:tbl>
              <a:tblPr/>
              <a:tblGrid>
                <a:gridCol w="6030088"/>
                <a:gridCol w="801757"/>
              </a:tblGrid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</a:t>
                      </a:r>
                      <a:r>
                        <a:rPr lang="en-US" sz="1200" b="0" i="0" u="sng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GCCACCCGATCCACTGG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AGCAAAACTTCAAAGGGTAAAATGGGCC</a:t>
                      </a:r>
                      <a:endParaRPr 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IL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g</a:t>
                      </a:r>
                      <a:r>
                        <a:rPr lang="en-US" altLang="zh-CN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-TGGGGGAGCAAAACTTCAAAGGGTAAAATGGGCC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--TGGGGGAGCAAAACTTCAAAGGGTAAAATGGGCC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--------GGGGGAGCAAAACTTCAAAGGGTAAAATGGGCC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8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----------GGGGGAGCAAAACTTCAAAGGGTAAAATGGGCC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0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-----------AAAACTTCAAAGGGTAAAATGGGCC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1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------------------GGGAGCAAAACTTCAAAGGGTAAAATGGGCC 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8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---------------------GGGTAAAATGGGCC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1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---------------------AAACTTCAAAGGGTAAAATGGGCC 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1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---------------------AAAACTTCAAAGGGTAAAATGGGCC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1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----------------------GCAAAACTTCAAAGGGTAAAATGGGCC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2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TCCACT</a:t>
                      </a:r>
                      <a:r>
                        <a:rPr lang="en-US" sz="1200" b="0" i="0" u="none" strike="noStrike" dirty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TTT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GGAGCAAAACTTCAAAGGGTAAAATGGGCC </a:t>
                      </a:r>
                      <a:endParaRPr 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3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TGAATGGAGCCACCCGA</a:t>
                      </a:r>
                      <a:r>
                        <a:rPr lang="en-US" sz="1200" b="0" i="0" u="none" strike="noStrike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AG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----</a:t>
                      </a:r>
                      <a:r>
                        <a:rPr lang="en-US" sz="1200" b="0" i="0" u="none" strike="noStrike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TTT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GGGAGCAAAACTTCAAAGGGTAAAATGGGCC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, 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4</a:t>
                      </a:r>
                      <a:endParaRPr 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</a:t>
                      </a:r>
                      <a:r>
                        <a:rPr lang="zh-CN" sz="1200" b="0" i="0" u="sng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TGGACCTTGAATGCTGG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G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  <a:r>
                        <a:rPr lang="en-US" altLang="zh-CN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TG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T--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C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6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9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T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9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</a:t>
                      </a:r>
                      <a:r>
                        <a:rPr lang="zh-CN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GG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</a:t>
                      </a:r>
                      <a:r>
                        <a:rPr lang="zh-CN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TTAG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AATGC</a:t>
                      </a:r>
                      <a:r>
                        <a:rPr lang="zh-CN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TTT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CTTCTGGCTTCTGACC</a:t>
                      </a:r>
                      <a:r>
                        <a:rPr lang="en-US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TAGCT</a:t>
                      </a: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3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CTTAGGGTGGACCTTG</a:t>
                      </a:r>
                      <a:r>
                        <a:rPr lang="zh-CN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GAGCCACTTCTGGCTTAG</a:t>
                      </a:r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TGGTGGAGCCA</a:t>
                      </a:r>
                      <a:r>
                        <a:rPr lang="zh-CN" alt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TTCTGG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</a:t>
                      </a:r>
                      <a:r>
                        <a:rPr lang="en-US" sz="1200" b="0" i="0" u="sng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GAGTTCTCTTTGGAGGA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TCATACATGCCTTCTAATCAAAGAACCA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G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  <a:r>
                        <a:rPr lang="en-US" altLang="zh-CN" sz="1200" b="0" i="0" u="none" strike="noStrike" baseline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</a:t>
                      </a:r>
                      <a:r>
                        <a:rPr lang="zh-CN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</a:t>
                      </a:r>
                      <a:endParaRPr lang="zh-CN" sz="1200" b="0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A-GACGGTCATACATGCCTTCTAATCAAAGAACCA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A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TCATACATGCCTTCTAATCAAAGAACCA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-CGGTCATACATGCCTTCTAATCAAAGAACCA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CGGTCATACATGCCTTCTAATCAAAGAACCA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6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-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--------------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GGACGGTCATACATGCCTTCTAATCAAAGAACCA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5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95079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AAAGTATGGGAGTTCTCTTTGGAG-</a:t>
                      </a:r>
                      <a:r>
                        <a:rPr lang="en-US" sz="1200" b="0" i="0" u="none" strike="noStrike" smtClean="0">
                          <a:solidFill>
                            <a:srgbClr val="0070C0"/>
                          </a:solidFill>
                          <a:effectLst/>
                          <a:latin typeface="Courier New"/>
                        </a:rPr>
                        <a:t>A</a:t>
                      </a:r>
                      <a:r>
                        <a:rPr lang="en-US" sz="1200" b="0" i="0" u="none" strike="noStrike" smtClean="0">
                          <a:solidFill>
                            <a:srgbClr val="000000"/>
                          </a:solidFill>
                          <a:effectLst/>
                          <a:latin typeface="Courier New"/>
                        </a:rPr>
                        <a:t>ACGGTCATACATGCCTTCTAATCAAAGAACCA </a:t>
                      </a:r>
                      <a:endParaRPr lang="zh-CN" sz="1200" b="0" i="0" u="none" strike="noStrike">
                        <a:solidFill>
                          <a:srgbClr val="000000"/>
                        </a:solidFill>
                        <a:effectLst/>
                        <a:latin typeface="Courier New"/>
                      </a:endParaRPr>
                    </a:p>
                  </a:txBody>
                  <a:tcPr marL="9525" marR="9525" marT="11021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  <a:r>
                        <a:rPr lang="en-US" alt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, </a:t>
                      </a:r>
                      <a:r>
                        <a:rPr lang="zh-CN" sz="12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r>
                        <a:rPr lang="zh-CN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9525" marR="9525" marT="11021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21" name="TextBox 20"/>
          <p:cNvSpPr txBox="1"/>
          <p:nvPr/>
        </p:nvSpPr>
        <p:spPr>
          <a:xfrm rot="10800000">
            <a:off x="1057424" y="1775120"/>
            <a:ext cx="369332" cy="63726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IL2rg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 rot="10800000">
            <a:off x="972395" y="3924548"/>
            <a:ext cx="369332" cy="78127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RAG1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 rot="10800000">
            <a:off x="972394" y="5577143"/>
            <a:ext cx="369332" cy="86768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RAG2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0800000">
            <a:off x="1066949" y="8097423"/>
            <a:ext cx="369332" cy="57965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IL2rg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0800000">
            <a:off x="971601" y="9710402"/>
            <a:ext cx="369332" cy="694866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RAG1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0800000">
            <a:off x="952783" y="11611413"/>
            <a:ext cx="369332" cy="66606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RAG2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 rot="10800000">
            <a:off x="956742" y="13285588"/>
            <a:ext cx="369332" cy="486054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TIKI1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0800000">
            <a:off x="962307" y="14696945"/>
            <a:ext cx="369332" cy="388843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200" smtClean="0">
                <a:latin typeface="Arial" panose="020B0604020202020204" pitchFamily="34" charset="0"/>
                <a:cs typeface="Arial" panose="020B0604020202020204" pitchFamily="34" charset="0"/>
              </a:rPr>
              <a:t>ALB</a:t>
            </a:r>
            <a:endParaRPr lang="zh-CN" altLang="en-US" sz="12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777312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</TotalTime>
  <Words>370</Words>
  <Application>Microsoft Office PowerPoint</Application>
  <PresentationFormat>自定义</PresentationFormat>
  <Paragraphs>162</Paragraphs>
  <Slides>1</Slides>
  <Notes>1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anquanmei</dc:creator>
  <cp:lastModifiedBy>Yanquanmei</cp:lastModifiedBy>
  <cp:revision>9</cp:revision>
  <dcterms:created xsi:type="dcterms:W3CDTF">2014-06-09T03:35:05Z</dcterms:created>
  <dcterms:modified xsi:type="dcterms:W3CDTF">2014-07-09T02:15:18Z</dcterms:modified>
</cp:coreProperties>
</file>